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0" r:id="rId2"/>
    <p:sldId id="261" r:id="rId3"/>
  </p:sldIdLst>
  <p:sldSz cx="10439400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  <a:srgbClr val="AEAEAE"/>
    <a:srgbClr val="000000"/>
    <a:srgbClr val="009900"/>
    <a:srgbClr val="00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5D7031C-553A-4556-828C-576787C120CD}" v="1" dt="2026-01-24T23:43:23.7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85961" autoAdjust="0"/>
  </p:normalViewPr>
  <p:slideViewPr>
    <p:cSldViewPr snapToGrid="0">
      <p:cViewPr varScale="1">
        <p:scale>
          <a:sx n="59" d="100"/>
          <a:sy n="59" d="100"/>
        </p:scale>
        <p:origin x="100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zzal, Reham" userId="d12a97d8-5e10-4317-a0b5-383f2fee3443" providerId="ADAL" clId="{B515B93E-2538-43F6-8C6D-D16CB7DB485F}"/>
    <pc:docChg chg="modSld">
      <pc:chgData name="Nazzal, Reham" userId="d12a97d8-5e10-4317-a0b5-383f2fee3443" providerId="ADAL" clId="{B515B93E-2538-43F6-8C6D-D16CB7DB485F}" dt="2026-01-24T23:43:45.476" v="1" actId="255"/>
      <pc:docMkLst>
        <pc:docMk/>
      </pc:docMkLst>
      <pc:sldChg chg="modSp mod">
        <pc:chgData name="Nazzal, Reham" userId="d12a97d8-5e10-4317-a0b5-383f2fee3443" providerId="ADAL" clId="{B515B93E-2538-43F6-8C6D-D16CB7DB485F}" dt="2026-01-24T23:43:45.476" v="1" actId="255"/>
        <pc:sldMkLst>
          <pc:docMk/>
          <pc:sldMk cId="3869548512" sldId="261"/>
        </pc:sldMkLst>
        <pc:spChg chg="mod">
          <ac:chgData name="Nazzal, Reham" userId="d12a97d8-5e10-4317-a0b5-383f2fee3443" providerId="ADAL" clId="{B515B93E-2538-43F6-8C6D-D16CB7DB485F}" dt="2026-01-24T23:43:45.476" v="1" actId="255"/>
          <ac:spMkLst>
            <pc:docMk/>
            <pc:sldMk cId="3869548512" sldId="261"/>
            <ac:spMk id="2" creationId="{886DF144-2799-8AF2-C523-265D24EFD88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891C6C-65F8-45DB-9E97-779A3D3463F5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98575" y="1143000"/>
            <a:ext cx="4260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A7D7C7-B6C9-4EA6-AE3F-27B63767C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7242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98575" y="1143000"/>
            <a:ext cx="42608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9A7D7C7-B6C9-4EA6-AE3F-27B63767CC3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47232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2955" y="1237197"/>
            <a:ext cx="8873490" cy="2631887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4925" y="3970580"/>
            <a:ext cx="7829550" cy="1825171"/>
          </a:xfrm>
        </p:spPr>
        <p:txBody>
          <a:bodyPr/>
          <a:lstStyle>
            <a:lvl1pPr marL="0" indent="0" algn="ctr">
              <a:buNone/>
              <a:defRPr sz="2646"/>
            </a:lvl1pPr>
            <a:lvl2pPr marL="503972" indent="0" algn="ctr">
              <a:buNone/>
              <a:defRPr sz="2205"/>
            </a:lvl2pPr>
            <a:lvl3pPr marL="1007943" indent="0" algn="ctr">
              <a:buNone/>
              <a:defRPr sz="1984"/>
            </a:lvl3pPr>
            <a:lvl4pPr marL="1511915" indent="0" algn="ctr">
              <a:buNone/>
              <a:defRPr sz="1764"/>
            </a:lvl4pPr>
            <a:lvl5pPr marL="2015886" indent="0" algn="ctr">
              <a:buNone/>
              <a:defRPr sz="1764"/>
            </a:lvl5pPr>
            <a:lvl6pPr marL="2519858" indent="0" algn="ctr">
              <a:buNone/>
              <a:defRPr sz="1764"/>
            </a:lvl6pPr>
            <a:lvl7pPr marL="3023829" indent="0" algn="ctr">
              <a:buNone/>
              <a:defRPr sz="1764"/>
            </a:lvl7pPr>
            <a:lvl8pPr marL="3527801" indent="0" algn="ctr">
              <a:buNone/>
              <a:defRPr sz="1764"/>
            </a:lvl8pPr>
            <a:lvl9pPr marL="4031772" indent="0" algn="ctr">
              <a:buNone/>
              <a:defRPr sz="176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5109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295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70696" y="402483"/>
            <a:ext cx="2250996" cy="64064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7710" y="402483"/>
            <a:ext cx="6622494" cy="64064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0249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8547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2272" y="1884671"/>
            <a:ext cx="9003983" cy="3144614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2272" y="5059035"/>
            <a:ext cx="9003983" cy="1653678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>
                    <a:tint val="82000"/>
                  </a:schemeClr>
                </a:solidFill>
              </a:defRPr>
            </a:lvl1pPr>
            <a:lvl2pPr marL="503972" indent="0">
              <a:buNone/>
              <a:defRPr sz="2205">
                <a:solidFill>
                  <a:schemeClr val="tx1">
                    <a:tint val="82000"/>
                  </a:schemeClr>
                </a:solidFill>
              </a:defRPr>
            </a:lvl2pPr>
            <a:lvl3pPr marL="1007943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3pPr>
            <a:lvl4pPr marL="1511915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4pPr>
            <a:lvl5pPr marL="2015886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5pPr>
            <a:lvl6pPr marL="2519858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6pPr>
            <a:lvl7pPr marL="3023829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7pPr>
            <a:lvl8pPr marL="3527801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8pPr>
            <a:lvl9pPr marL="4031772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1440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7709" y="2012414"/>
            <a:ext cx="4436745" cy="47965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84946" y="2012414"/>
            <a:ext cx="4436745" cy="47965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2113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8" y="402484"/>
            <a:ext cx="9003983" cy="14611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9070" y="1853171"/>
            <a:ext cx="4416355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9070" y="2761381"/>
            <a:ext cx="4416355" cy="40615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84947" y="1853171"/>
            <a:ext cx="4438105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84947" y="2761381"/>
            <a:ext cx="4438105" cy="40615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7392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9913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4129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9" y="503978"/>
            <a:ext cx="3366978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38105" y="1088455"/>
            <a:ext cx="5284946" cy="5372269"/>
          </a:xfrm>
        </p:spPr>
        <p:txBody>
          <a:bodyPr/>
          <a:lstStyle>
            <a:lvl1pPr>
              <a:defRPr sz="3527"/>
            </a:lvl1pPr>
            <a:lvl2pPr>
              <a:defRPr sz="3086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069" y="2267902"/>
            <a:ext cx="3366978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091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9" y="503978"/>
            <a:ext cx="3366978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38105" y="1088455"/>
            <a:ext cx="5284946" cy="5372269"/>
          </a:xfrm>
        </p:spPr>
        <p:txBody>
          <a:bodyPr anchor="t"/>
          <a:lstStyle>
            <a:lvl1pPr marL="0" indent="0">
              <a:buNone/>
              <a:defRPr sz="3527"/>
            </a:lvl1pPr>
            <a:lvl2pPr marL="503972" indent="0">
              <a:buNone/>
              <a:defRPr sz="3086"/>
            </a:lvl2pPr>
            <a:lvl3pPr marL="1007943" indent="0">
              <a:buNone/>
              <a:defRPr sz="2646"/>
            </a:lvl3pPr>
            <a:lvl4pPr marL="1511915" indent="0">
              <a:buNone/>
              <a:defRPr sz="2205"/>
            </a:lvl4pPr>
            <a:lvl5pPr marL="2015886" indent="0">
              <a:buNone/>
              <a:defRPr sz="2205"/>
            </a:lvl5pPr>
            <a:lvl6pPr marL="2519858" indent="0">
              <a:buNone/>
              <a:defRPr sz="2205"/>
            </a:lvl6pPr>
            <a:lvl7pPr marL="3023829" indent="0">
              <a:buNone/>
              <a:defRPr sz="2205"/>
            </a:lvl7pPr>
            <a:lvl8pPr marL="3527801" indent="0">
              <a:buNone/>
              <a:defRPr sz="2205"/>
            </a:lvl8pPr>
            <a:lvl9pPr marL="4031772" indent="0">
              <a:buNone/>
              <a:defRPr sz="220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069" y="2267902"/>
            <a:ext cx="3366978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23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7709" y="402484"/>
            <a:ext cx="9003983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7709" y="2012414"/>
            <a:ext cx="9003983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7709" y="7006700"/>
            <a:ext cx="2348865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6A1766-B522-4BB4-9108-2625EB50BE23}" type="datetimeFigureOut">
              <a:rPr lang="en-GB" smtClean="0"/>
              <a:t>24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58051" y="7006700"/>
            <a:ext cx="352329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72826" y="7006700"/>
            <a:ext cx="2348865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907404-7ECC-4BE5-8797-A0739DA8A9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6623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7943" rtl="0" eaLnBrk="1" latinLnBrk="0" hangingPunct="1">
        <a:lnSpc>
          <a:spcPct val="90000"/>
        </a:lnSpc>
        <a:spcBef>
          <a:spcPct val="0"/>
        </a:spcBef>
        <a:buNone/>
        <a:defRPr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986" indent="-251986" algn="l" defTabSz="1007943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6" kern="1200">
          <a:solidFill>
            <a:schemeClr val="tx1"/>
          </a:solidFill>
          <a:latin typeface="+mn-lt"/>
          <a:ea typeface="+mn-ea"/>
          <a:cs typeface="+mn-cs"/>
        </a:defRPr>
      </a:lvl1pPr>
      <a:lvl2pPr marL="75595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59929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3900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7872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1844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5815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7978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3758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39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7943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1915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5886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19858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3829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7801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17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Group 69">
            <a:extLst>
              <a:ext uri="{FF2B5EF4-FFF2-40B4-BE49-F238E27FC236}">
                <a16:creationId xmlns:a16="http://schemas.microsoft.com/office/drawing/2014/main" id="{0D7FB604-3C6F-5D5D-32E0-30850C12F7B2}"/>
              </a:ext>
            </a:extLst>
          </p:cNvPr>
          <p:cNvGrpSpPr/>
          <p:nvPr/>
        </p:nvGrpSpPr>
        <p:grpSpPr>
          <a:xfrm>
            <a:off x="0" y="1582376"/>
            <a:ext cx="10439400" cy="1377465"/>
            <a:chOff x="0" y="698238"/>
            <a:chExt cx="12192000" cy="1608718"/>
          </a:xfrm>
        </p:grpSpPr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5A07D9EA-3CFA-A3B7-D3C1-6255395153B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729060"/>
              <a:ext cx="12192000" cy="1577896"/>
            </a:xfrm>
            <a:prstGeom prst="rect">
              <a:avLst/>
            </a:prstGeom>
          </p:spPr>
        </p:pic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5512739A-1BDA-A015-04D6-8AD92CAAB081}"/>
                </a:ext>
              </a:extLst>
            </p:cNvPr>
            <p:cNvSpPr/>
            <p:nvPr/>
          </p:nvSpPr>
          <p:spPr>
            <a:xfrm>
              <a:off x="6349428" y="698238"/>
              <a:ext cx="554805" cy="1577895"/>
            </a:xfrm>
            <a:prstGeom prst="rect">
              <a:avLst/>
            </a:prstGeom>
            <a:solidFill>
              <a:srgbClr val="000000">
                <a:alpha val="5882"/>
              </a:srgbClr>
            </a:solidFill>
            <a:ln>
              <a:solidFill>
                <a:schemeClr val="accent4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B1FCEF90-6627-7012-8CC4-BA3573CE8EC8}"/>
              </a:ext>
            </a:extLst>
          </p:cNvPr>
          <p:cNvGrpSpPr/>
          <p:nvPr/>
        </p:nvGrpSpPr>
        <p:grpSpPr>
          <a:xfrm>
            <a:off x="411120" y="3547728"/>
            <a:ext cx="9570466" cy="489742"/>
            <a:chOff x="480141" y="2962717"/>
            <a:chExt cx="11177186" cy="571962"/>
          </a:xfrm>
        </p:grpSpPr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83D32EC6-81D9-C6CD-F101-73F0E66127C3}"/>
                </a:ext>
              </a:extLst>
            </p:cNvPr>
            <p:cNvCxnSpPr/>
            <p:nvPr/>
          </p:nvCxnSpPr>
          <p:spPr>
            <a:xfrm>
              <a:off x="480141" y="3241226"/>
              <a:ext cx="11124000" cy="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064EACCD-CC3A-692A-47E3-77E0CB238133}"/>
                </a:ext>
              </a:extLst>
            </p:cNvPr>
            <p:cNvSpPr/>
            <p:nvPr/>
          </p:nvSpPr>
          <p:spPr>
            <a:xfrm>
              <a:off x="669659" y="2988133"/>
              <a:ext cx="45719" cy="546546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A64DE640-731E-0A90-6DE9-C9DEAB09F499}"/>
                </a:ext>
              </a:extLst>
            </p:cNvPr>
            <p:cNvSpPr/>
            <p:nvPr/>
          </p:nvSpPr>
          <p:spPr>
            <a:xfrm>
              <a:off x="5834929" y="2967953"/>
              <a:ext cx="68400" cy="546546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8678FE4B-0017-FCF9-43A9-9415FF7E2068}"/>
                </a:ext>
              </a:extLst>
            </p:cNvPr>
            <p:cNvSpPr/>
            <p:nvPr/>
          </p:nvSpPr>
          <p:spPr>
            <a:xfrm>
              <a:off x="5996422" y="2967953"/>
              <a:ext cx="45719" cy="546546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3591BC5C-3477-82A2-36C4-A9BDD86E2343}"/>
                </a:ext>
              </a:extLst>
            </p:cNvPr>
            <p:cNvSpPr/>
            <p:nvPr/>
          </p:nvSpPr>
          <p:spPr>
            <a:xfrm>
              <a:off x="7202015" y="2967953"/>
              <a:ext cx="45719" cy="546546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0D72EEF-6C4B-70D5-7FF6-CB0BBF903EAB}"/>
                </a:ext>
              </a:extLst>
            </p:cNvPr>
            <p:cNvSpPr/>
            <p:nvPr/>
          </p:nvSpPr>
          <p:spPr>
            <a:xfrm>
              <a:off x="9264863" y="2965231"/>
              <a:ext cx="61200" cy="546546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74F0EC3-8A44-C549-E849-273C268597E4}"/>
                </a:ext>
              </a:extLst>
            </p:cNvPr>
            <p:cNvSpPr/>
            <p:nvPr/>
          </p:nvSpPr>
          <p:spPr>
            <a:xfrm>
              <a:off x="10470457" y="2964770"/>
              <a:ext cx="97534" cy="546546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51666E02-4C62-7172-6F62-FE8D58CE2176}"/>
                </a:ext>
              </a:extLst>
            </p:cNvPr>
            <p:cNvSpPr/>
            <p:nvPr/>
          </p:nvSpPr>
          <p:spPr>
            <a:xfrm>
              <a:off x="10664171" y="2964770"/>
              <a:ext cx="45719" cy="546546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395DD15F-ABB1-4AFA-4D5C-8F77F610F90B}"/>
                </a:ext>
              </a:extLst>
            </p:cNvPr>
            <p:cNvSpPr/>
            <p:nvPr/>
          </p:nvSpPr>
          <p:spPr>
            <a:xfrm>
              <a:off x="10837521" y="2963065"/>
              <a:ext cx="64800" cy="546546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12091B6F-CA89-2987-AB80-2484EC7DC154}"/>
                </a:ext>
              </a:extLst>
            </p:cNvPr>
            <p:cNvSpPr/>
            <p:nvPr/>
          </p:nvSpPr>
          <p:spPr>
            <a:xfrm>
              <a:off x="11398301" y="2962717"/>
              <a:ext cx="45719" cy="546546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73835248-535F-29C9-7387-10184AC77B16}"/>
                </a:ext>
              </a:extLst>
            </p:cNvPr>
            <p:cNvSpPr/>
            <p:nvPr/>
          </p:nvSpPr>
          <p:spPr>
            <a:xfrm>
              <a:off x="11463379" y="3091990"/>
              <a:ext cx="193948" cy="288000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</p:grp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9BBB265-C016-887F-B03F-BA99C02FFC13}"/>
              </a:ext>
            </a:extLst>
          </p:cNvPr>
          <p:cNvCxnSpPr/>
          <p:nvPr/>
        </p:nvCxnSpPr>
        <p:spPr>
          <a:xfrm>
            <a:off x="613439" y="3786198"/>
            <a:ext cx="0" cy="43155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E3FF9FD-57C9-5017-ADF9-4489D566A84B}"/>
              </a:ext>
            </a:extLst>
          </p:cNvPr>
          <p:cNvCxnSpPr/>
          <p:nvPr/>
        </p:nvCxnSpPr>
        <p:spPr>
          <a:xfrm>
            <a:off x="4985547" y="3786198"/>
            <a:ext cx="0" cy="43155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8" name="Group 37">
            <a:extLst>
              <a:ext uri="{FF2B5EF4-FFF2-40B4-BE49-F238E27FC236}">
                <a16:creationId xmlns:a16="http://schemas.microsoft.com/office/drawing/2014/main" id="{7EBE89A1-43BC-9D7D-FCFA-6ADFE6BE19F3}"/>
              </a:ext>
            </a:extLst>
          </p:cNvPr>
          <p:cNvGrpSpPr/>
          <p:nvPr/>
        </p:nvGrpSpPr>
        <p:grpSpPr>
          <a:xfrm>
            <a:off x="704112" y="4948467"/>
            <a:ext cx="9045154" cy="245331"/>
            <a:chOff x="822320" y="4598617"/>
            <a:chExt cx="10563684" cy="286518"/>
          </a:xfrm>
        </p:grpSpPr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73498318-01C8-0F49-E3B9-315541E3DCAC}"/>
                </a:ext>
              </a:extLst>
            </p:cNvPr>
            <p:cNvSpPr/>
            <p:nvPr/>
          </p:nvSpPr>
          <p:spPr>
            <a:xfrm>
              <a:off x="822320" y="4598617"/>
              <a:ext cx="617861" cy="2577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B2D3E09A-3253-EEA2-E396-D14F69BF6F57}"/>
                </a:ext>
              </a:extLst>
            </p:cNvPr>
            <p:cNvSpPr/>
            <p:nvPr/>
          </p:nvSpPr>
          <p:spPr>
            <a:xfrm>
              <a:off x="2681055" y="4627379"/>
              <a:ext cx="8704949" cy="2577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</p:grp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59D70EB-2EB0-C5ED-BA66-BE716F3DA525}"/>
              </a:ext>
            </a:extLst>
          </p:cNvPr>
          <p:cNvCxnSpPr>
            <a:cxnSpLocks/>
          </p:cNvCxnSpPr>
          <p:nvPr/>
        </p:nvCxnSpPr>
        <p:spPr>
          <a:xfrm>
            <a:off x="602829" y="4202841"/>
            <a:ext cx="3766979" cy="817699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3D924553-9113-C149-0377-74DB799A8FBA}"/>
              </a:ext>
            </a:extLst>
          </p:cNvPr>
          <p:cNvCxnSpPr>
            <a:cxnSpLocks/>
          </p:cNvCxnSpPr>
          <p:nvPr/>
        </p:nvCxnSpPr>
        <p:spPr>
          <a:xfrm flipH="1" flipV="1">
            <a:off x="4974938" y="4199163"/>
            <a:ext cx="1366840" cy="821378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39E08DAF-918D-B1C6-1C65-592F3AF8D0C0}"/>
              </a:ext>
            </a:extLst>
          </p:cNvPr>
          <p:cNvSpPr txBox="1"/>
          <p:nvPr/>
        </p:nvSpPr>
        <p:spPr>
          <a:xfrm>
            <a:off x="61581" y="1635506"/>
            <a:ext cx="475052" cy="3294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541" b="1" dirty="0"/>
              <a:t>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1850B37-1438-6638-53AF-DBF867C0E99B}"/>
              </a:ext>
            </a:extLst>
          </p:cNvPr>
          <p:cNvSpPr txBox="1"/>
          <p:nvPr/>
        </p:nvSpPr>
        <p:spPr>
          <a:xfrm>
            <a:off x="60117" y="3463864"/>
            <a:ext cx="475052" cy="3294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541" b="1" dirty="0"/>
              <a:t>b</a:t>
            </a: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81AD3C38-77A3-6055-0320-DE9513C878E7}"/>
              </a:ext>
            </a:extLst>
          </p:cNvPr>
          <p:cNvGrpSpPr/>
          <p:nvPr/>
        </p:nvGrpSpPr>
        <p:grpSpPr>
          <a:xfrm>
            <a:off x="49855" y="4975526"/>
            <a:ext cx="9236509" cy="1122881"/>
            <a:chOff x="58225" y="4630220"/>
            <a:chExt cx="10787164" cy="1311394"/>
          </a:xfrm>
        </p:grpSpPr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57E90F82-BD9F-7C8E-8BEE-388A6AB8F7D9}"/>
                </a:ext>
              </a:extLst>
            </p:cNvPr>
            <p:cNvGrpSpPr/>
            <p:nvPr/>
          </p:nvGrpSpPr>
          <p:grpSpPr>
            <a:xfrm>
              <a:off x="58225" y="4630220"/>
              <a:ext cx="10787164" cy="1311394"/>
              <a:chOff x="58225" y="4630220"/>
              <a:chExt cx="10787164" cy="1311394"/>
            </a:xfrm>
          </p:grpSpPr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08DB356E-8987-2DE7-0B9E-72D462C65E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12211" t="32962"/>
              <a:stretch/>
            </p:blipFill>
            <p:spPr>
              <a:xfrm>
                <a:off x="1487364" y="4747843"/>
                <a:ext cx="9199399" cy="772736"/>
              </a:xfrm>
              <a:prstGeom prst="rect">
                <a:avLst/>
              </a:prstGeom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C750A440-C133-6815-865C-73F7E786FE40}"/>
                  </a:ext>
                </a:extLst>
              </p:cNvPr>
              <p:cNvSpPr txBox="1"/>
              <p:nvPr/>
            </p:nvSpPr>
            <p:spPr>
              <a:xfrm>
                <a:off x="1440882" y="5502789"/>
                <a:ext cx="9404507" cy="4388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21" b="1" dirty="0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/>
                  <a:t>    </a:t>
                </a:r>
                <a:r>
                  <a:rPr lang="en-GB" sz="921" b="1" dirty="0">
                    <a:solidFill>
                      <a:srgbClr val="FF0000"/>
                    </a:solidFill>
                  </a:rPr>
                  <a:t>T</a:t>
                </a:r>
                <a:r>
                  <a:rPr lang="en-GB" sz="921" b="1" dirty="0"/>
                  <a:t>    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/>
                  <a:t>   G   </a:t>
                </a:r>
                <a:r>
                  <a:rPr lang="en-GB" sz="921" b="1" dirty="0" err="1"/>
                  <a:t>G</a:t>
                </a:r>
                <a:r>
                  <a:rPr lang="en-GB" sz="921" b="1" dirty="0"/>
                  <a:t>   </a:t>
                </a:r>
                <a:r>
                  <a:rPr lang="en-GB" sz="921" b="1" dirty="0" err="1"/>
                  <a:t>G</a:t>
                </a:r>
                <a:r>
                  <a:rPr lang="en-GB" sz="921" b="1" dirty="0"/>
                  <a:t>   </a:t>
                </a:r>
                <a:r>
                  <a:rPr lang="en-GB" sz="921" b="1" dirty="0" err="1"/>
                  <a:t>G</a:t>
                </a:r>
                <a:r>
                  <a:rPr lang="en-GB" sz="921" b="1" dirty="0"/>
                  <a:t>   </a:t>
                </a:r>
                <a:r>
                  <a:rPr lang="en-GB" sz="921" b="1" dirty="0">
                    <a:solidFill>
                      <a:srgbClr val="009900"/>
                    </a:solidFill>
                  </a:rPr>
                  <a:t>A</a:t>
                </a:r>
                <a:r>
                  <a:rPr lang="en-GB" sz="921" b="1" dirty="0"/>
                  <a:t>   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/>
                  <a:t>   </a:t>
                </a:r>
                <a:r>
                  <a:rPr lang="en-GB" sz="921" b="1" dirty="0">
                    <a:solidFill>
                      <a:srgbClr val="FF0000"/>
                    </a:solidFill>
                  </a:rPr>
                  <a:t>T </a:t>
                </a:r>
                <a:r>
                  <a:rPr lang="en-GB" sz="921" b="1" dirty="0"/>
                  <a:t>  G   </a:t>
                </a:r>
                <a:r>
                  <a:rPr lang="en-GB" sz="921" b="1" dirty="0" err="1"/>
                  <a:t>G</a:t>
                </a:r>
                <a:r>
                  <a:rPr lang="en-GB" sz="921" b="1" dirty="0"/>
                  <a:t>    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/>
                  <a:t>    </a:t>
                </a:r>
                <a:r>
                  <a:rPr lang="en-GB" sz="921" b="1" dirty="0">
                    <a:solidFill>
                      <a:srgbClr val="FF0000"/>
                    </a:solidFill>
                  </a:rPr>
                  <a:t>T </a:t>
                </a:r>
                <a:r>
                  <a:rPr lang="en-GB" sz="921" b="1" dirty="0"/>
                  <a:t>  </a:t>
                </a:r>
                <a:r>
                  <a:rPr lang="en-GB" sz="921" b="1" dirty="0">
                    <a:solidFill>
                      <a:srgbClr val="009900"/>
                    </a:solidFill>
                  </a:rPr>
                  <a:t>A</a:t>
                </a:r>
                <a:r>
                  <a:rPr lang="en-GB" sz="921" b="1" dirty="0"/>
                  <a:t>   G   </a:t>
                </a:r>
                <a:r>
                  <a:rPr lang="en-GB" sz="921" b="1" dirty="0">
                    <a:solidFill>
                      <a:srgbClr val="009900"/>
                    </a:solidFill>
                  </a:rPr>
                  <a:t>A</a:t>
                </a:r>
                <a:r>
                  <a:rPr lang="en-GB" sz="921" b="1" dirty="0"/>
                  <a:t>   </a:t>
                </a:r>
                <a:r>
                  <a:rPr lang="en-GB" sz="921" b="1" dirty="0">
                    <a:solidFill>
                      <a:srgbClr val="FF0000"/>
                    </a:solidFill>
                  </a:rPr>
                  <a:t>T</a:t>
                </a:r>
                <a:r>
                  <a:rPr lang="en-GB" sz="921" b="1" dirty="0"/>
                  <a:t>   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/>
                  <a:t>    </a:t>
                </a:r>
                <a:r>
                  <a:rPr lang="en-GB" sz="921" b="1" dirty="0">
                    <a:solidFill>
                      <a:srgbClr val="FF0000"/>
                    </a:solidFill>
                  </a:rPr>
                  <a:t>T </a:t>
                </a:r>
                <a:r>
                  <a:rPr lang="en-GB" sz="921" b="1" dirty="0"/>
                  <a:t>   </a:t>
                </a:r>
                <a:r>
                  <a:rPr lang="en-GB" sz="921" b="1" dirty="0">
                    <a:solidFill>
                      <a:srgbClr val="0000FF"/>
                    </a:solidFill>
                    <a:highlight>
                      <a:srgbClr val="FFFF00"/>
                    </a:highlight>
                  </a:rPr>
                  <a:t>C</a:t>
                </a:r>
                <a:r>
                  <a:rPr lang="en-GB" sz="921" b="1" dirty="0">
                    <a:highlight>
                      <a:srgbClr val="FFFF00"/>
                    </a:highlight>
                  </a:rPr>
                  <a:t>   </a:t>
                </a:r>
                <a:r>
                  <a:rPr lang="en-GB" sz="921" b="1" dirty="0">
                    <a:solidFill>
                      <a:srgbClr val="FF0000"/>
                    </a:solidFill>
                    <a:highlight>
                      <a:srgbClr val="FFFF00"/>
                    </a:highlight>
                  </a:rPr>
                  <a:t>T</a:t>
                </a:r>
                <a:r>
                  <a:rPr lang="en-GB" sz="921" b="1" dirty="0">
                    <a:highlight>
                      <a:srgbClr val="FFFF00"/>
                    </a:highlight>
                  </a:rPr>
                  <a:t>   </a:t>
                </a:r>
                <a:r>
                  <a:rPr lang="en-GB" sz="921" b="1" dirty="0">
                    <a:solidFill>
                      <a:srgbClr val="0000FF"/>
                    </a:solidFill>
                    <a:highlight>
                      <a:srgbClr val="FFFF00"/>
                    </a:highlight>
                  </a:rPr>
                  <a:t> C   </a:t>
                </a:r>
                <a:r>
                  <a:rPr lang="en-GB" sz="921" b="1" dirty="0">
                    <a:solidFill>
                      <a:srgbClr val="FF0000"/>
                    </a:solidFill>
                    <a:highlight>
                      <a:srgbClr val="FFFF00"/>
                    </a:highlight>
                  </a:rPr>
                  <a:t>T</a:t>
                </a:r>
                <a:r>
                  <a:rPr lang="en-GB" sz="921" b="1" dirty="0">
                    <a:highlight>
                      <a:srgbClr val="FFFF00"/>
                    </a:highlight>
                  </a:rPr>
                  <a:t>   </a:t>
                </a:r>
                <a:r>
                  <a:rPr lang="en-GB" sz="921" b="1" dirty="0">
                    <a:solidFill>
                      <a:srgbClr val="0000FF"/>
                    </a:solidFill>
                    <a:highlight>
                      <a:srgbClr val="FFFF00"/>
                    </a:highlight>
                  </a:rPr>
                  <a:t>C</a:t>
                </a:r>
                <a:r>
                  <a:rPr lang="en-GB" sz="921" b="1" dirty="0">
                    <a:highlight>
                      <a:srgbClr val="FFFF00"/>
                    </a:highlight>
                  </a:rPr>
                  <a:t>   </a:t>
                </a:r>
                <a:r>
                  <a:rPr lang="en-GB" sz="921" b="1" dirty="0">
                    <a:solidFill>
                      <a:srgbClr val="FF0000"/>
                    </a:solidFill>
                    <a:highlight>
                      <a:srgbClr val="FFFF00"/>
                    </a:highlight>
                  </a:rPr>
                  <a:t>T   </a:t>
                </a:r>
                <a:r>
                  <a:rPr lang="en-GB" sz="921" b="1" dirty="0" err="1">
                    <a:solidFill>
                      <a:srgbClr val="FF0000"/>
                    </a:solidFill>
                    <a:highlight>
                      <a:srgbClr val="FFFF00"/>
                    </a:highlight>
                  </a:rPr>
                  <a:t>T</a:t>
                </a:r>
                <a:r>
                  <a:rPr lang="en-GB" sz="921" b="1" dirty="0">
                    <a:solidFill>
                      <a:srgbClr val="FF0000"/>
                    </a:solidFill>
                    <a:highlight>
                      <a:srgbClr val="FFFF00"/>
                    </a:highlight>
                  </a:rPr>
                  <a:t>   </a:t>
                </a:r>
                <a:r>
                  <a:rPr lang="en-GB" sz="921" b="1" dirty="0">
                    <a:solidFill>
                      <a:srgbClr val="0000FF"/>
                    </a:solidFill>
                    <a:highlight>
                      <a:srgbClr val="FFFF00"/>
                    </a:highlight>
                  </a:rPr>
                  <a:t>C</a:t>
                </a:r>
                <a:r>
                  <a:rPr lang="en-GB" sz="921" b="1" dirty="0">
                    <a:highlight>
                      <a:srgbClr val="FFFF00"/>
                    </a:highlight>
                  </a:rPr>
                  <a:t>   </a:t>
                </a:r>
                <a:r>
                  <a:rPr lang="en-GB" sz="921" b="1" dirty="0" err="1">
                    <a:solidFill>
                      <a:srgbClr val="0000FF"/>
                    </a:solidFill>
                    <a:highlight>
                      <a:srgbClr val="FFFF00"/>
                    </a:highlight>
                  </a:rPr>
                  <a:t>C</a:t>
                </a:r>
                <a:r>
                  <a:rPr lang="en-GB" sz="921" b="1" dirty="0">
                    <a:highlight>
                      <a:srgbClr val="FFFF00"/>
                    </a:highlight>
                  </a:rPr>
                  <a:t>    </a:t>
                </a:r>
                <a:r>
                  <a:rPr lang="en-GB" sz="921" b="1" dirty="0" err="1">
                    <a:solidFill>
                      <a:srgbClr val="0000FF"/>
                    </a:solidFill>
                    <a:highlight>
                      <a:srgbClr val="FFFF00"/>
                    </a:highlight>
                  </a:rPr>
                  <a:t>C</a:t>
                </a:r>
                <a:r>
                  <a:rPr lang="en-GB" sz="921" b="1" dirty="0">
                    <a:highlight>
                      <a:srgbClr val="FFFF00"/>
                    </a:highlight>
                  </a:rPr>
                  <a:t>  </a:t>
                </a:r>
                <a:r>
                  <a:rPr lang="en-GB" sz="921" b="1" dirty="0" err="1">
                    <a:solidFill>
                      <a:srgbClr val="0000FF"/>
                    </a:solidFill>
                    <a:highlight>
                      <a:srgbClr val="FFFF00"/>
                    </a:highlight>
                  </a:rPr>
                  <a:t>C</a:t>
                </a:r>
                <a:r>
                  <a:rPr lang="en-GB" sz="921" b="1" dirty="0">
                    <a:highlight>
                      <a:srgbClr val="FFFF00"/>
                    </a:highlight>
                  </a:rPr>
                  <a:t>  </a:t>
                </a:r>
                <a:r>
                  <a:rPr lang="en-GB" sz="921" b="1" dirty="0">
                    <a:solidFill>
                      <a:srgbClr val="009900"/>
                    </a:solidFill>
                    <a:highlight>
                      <a:srgbClr val="FFFF00"/>
                    </a:highlight>
                  </a:rPr>
                  <a:t>A</a:t>
                </a:r>
                <a:r>
                  <a:rPr lang="en-GB" sz="921" b="1" dirty="0">
                    <a:highlight>
                      <a:srgbClr val="FFFF00"/>
                    </a:highlight>
                  </a:rPr>
                  <a:t>  G  </a:t>
                </a:r>
                <a:r>
                  <a:rPr lang="en-GB" sz="921" b="1" dirty="0">
                    <a:solidFill>
                      <a:srgbClr val="0000FF"/>
                    </a:solidFill>
                    <a:highlight>
                      <a:srgbClr val="FFFF00"/>
                    </a:highlight>
                  </a:rPr>
                  <a:t> C   </a:t>
                </a:r>
                <a:r>
                  <a:rPr lang="en-GB" sz="921" b="1" dirty="0">
                    <a:solidFill>
                      <a:srgbClr val="009900"/>
                    </a:solidFill>
                  </a:rPr>
                  <a:t>A</a:t>
                </a:r>
                <a:r>
                  <a:rPr lang="en-GB" sz="921" b="1" dirty="0"/>
                  <a:t>  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C   </a:t>
                </a:r>
                <a:r>
                  <a:rPr lang="en-GB" sz="921" b="1" dirty="0" err="1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   </a:t>
                </a:r>
                <a:r>
                  <a:rPr lang="en-GB" sz="921" b="1" dirty="0" err="1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   </a:t>
                </a:r>
                <a:r>
                  <a:rPr lang="en-GB" sz="921" b="1" dirty="0" err="1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   </a:t>
                </a:r>
                <a:r>
                  <a:rPr lang="en-GB" sz="921" b="1" dirty="0" err="1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   </a:t>
                </a:r>
                <a:r>
                  <a:rPr lang="en-GB" sz="921" b="1" dirty="0" err="1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   </a:t>
                </a:r>
                <a:r>
                  <a:rPr lang="en-GB" sz="921" b="1" dirty="0" err="1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 </a:t>
                </a:r>
                <a:r>
                  <a:rPr lang="en-GB" sz="921" b="1" dirty="0">
                    <a:solidFill>
                      <a:srgbClr val="009900"/>
                    </a:solidFill>
                  </a:rPr>
                  <a:t> A   </a:t>
                </a:r>
                <a:r>
                  <a:rPr lang="en-GB" sz="921" b="1" dirty="0"/>
                  <a:t>G  </a:t>
                </a:r>
                <a:r>
                  <a:rPr lang="en-GB" sz="921" b="1" dirty="0" err="1"/>
                  <a:t>G</a:t>
                </a:r>
                <a:r>
                  <a:rPr lang="en-GB" sz="921" b="1" dirty="0"/>
                  <a:t>  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/>
                  <a:t>   </a:t>
                </a:r>
                <a:r>
                  <a:rPr lang="en-GB" sz="921" b="1" dirty="0">
                    <a:solidFill>
                      <a:srgbClr val="009900"/>
                    </a:solidFill>
                  </a:rPr>
                  <a:t>A </a:t>
                </a:r>
                <a:r>
                  <a:rPr lang="en-GB" sz="921" b="1" dirty="0"/>
                  <a:t> G   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/>
                  <a:t>   </a:t>
                </a:r>
                <a:r>
                  <a:rPr lang="en-GB" sz="921" b="1" dirty="0">
                    <a:solidFill>
                      <a:srgbClr val="009900"/>
                    </a:solidFill>
                  </a:rPr>
                  <a:t>A</a:t>
                </a:r>
                <a:r>
                  <a:rPr lang="en-GB" sz="921" b="1" dirty="0"/>
                  <a:t>   G  </a:t>
                </a:r>
                <a:r>
                  <a:rPr lang="en-GB" sz="921" b="1" dirty="0">
                    <a:solidFill>
                      <a:srgbClr val="0000FF"/>
                    </a:solidFill>
                  </a:rPr>
                  <a:t>C</a:t>
                </a:r>
                <a:r>
                  <a:rPr lang="en-GB" sz="921" b="1" dirty="0"/>
                  <a:t>   </a:t>
                </a:r>
                <a:r>
                  <a:rPr lang="en-GB" sz="921" b="1" dirty="0">
                    <a:solidFill>
                      <a:srgbClr val="009900"/>
                    </a:solidFill>
                  </a:rPr>
                  <a:t>A</a:t>
                </a:r>
                <a:r>
                  <a:rPr lang="en-GB" sz="921" b="1" dirty="0"/>
                  <a:t>   G</a:t>
                </a:r>
              </a:p>
            </p:txBody>
          </p:sp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D4991F3F-9674-4396-12D4-35FE07613104}"/>
                  </a:ext>
                </a:extLst>
              </p:cNvPr>
              <p:cNvSpPr/>
              <p:nvPr/>
            </p:nvSpPr>
            <p:spPr>
              <a:xfrm>
                <a:off x="1487364" y="5498809"/>
                <a:ext cx="9217272" cy="257756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541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7847ABAF-DFF9-AD92-8FCA-B322CE37FFB1}"/>
                  </a:ext>
                </a:extLst>
              </p:cNvPr>
              <p:cNvSpPr txBox="1"/>
              <p:nvPr/>
            </p:nvSpPr>
            <p:spPr>
              <a:xfrm>
                <a:off x="1485963" y="4677925"/>
                <a:ext cx="9218673" cy="109272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GB" sz="1370" dirty="0"/>
              </a:p>
              <a:p>
                <a:endParaRPr lang="en-GB" sz="1370" dirty="0"/>
              </a:p>
              <a:p>
                <a:endParaRPr lang="en-GB" sz="1370" dirty="0"/>
              </a:p>
              <a:p>
                <a:endParaRPr lang="en-GB" sz="1370" dirty="0"/>
              </a:p>
            </p:txBody>
          </p: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E45DB64A-E93E-70B4-B342-F1CA0E8EDC30}"/>
                  </a:ext>
                </a:extLst>
              </p:cNvPr>
              <p:cNvCxnSpPr/>
              <p:nvPr/>
            </p:nvCxnSpPr>
            <p:spPr>
              <a:xfrm flipV="1">
                <a:off x="5095269" y="4673415"/>
                <a:ext cx="0" cy="82800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D79D31E8-5D87-4F37-12BF-B17E8259644C}"/>
                  </a:ext>
                </a:extLst>
              </p:cNvPr>
              <p:cNvCxnSpPr/>
              <p:nvPr/>
            </p:nvCxnSpPr>
            <p:spPr>
              <a:xfrm flipV="1">
                <a:off x="7394519" y="4676282"/>
                <a:ext cx="0" cy="82800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9C615BA1-26F5-1CED-CCAE-607A229E185E}"/>
                  </a:ext>
                </a:extLst>
              </p:cNvPr>
              <p:cNvSpPr txBox="1"/>
              <p:nvPr/>
            </p:nvSpPr>
            <p:spPr>
              <a:xfrm>
                <a:off x="3753486" y="4650299"/>
                <a:ext cx="5101035" cy="3847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541" b="1" dirty="0"/>
                  <a:t>        EXON 1                                                       EXON 2</a:t>
                </a:r>
              </a:p>
            </p:txBody>
          </p:sp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19A7E8B4-1ABA-23E0-EFC8-B07AE9951848}"/>
                  </a:ext>
                </a:extLst>
              </p:cNvPr>
              <p:cNvSpPr/>
              <p:nvPr/>
            </p:nvSpPr>
            <p:spPr>
              <a:xfrm>
                <a:off x="1941816" y="4717021"/>
                <a:ext cx="570796" cy="10853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541"/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442BEC09-5862-A20F-CB4C-6904620E3726}"/>
                  </a:ext>
                </a:extLst>
              </p:cNvPr>
              <p:cNvSpPr txBox="1"/>
              <p:nvPr/>
            </p:nvSpPr>
            <p:spPr>
              <a:xfrm>
                <a:off x="58225" y="4630220"/>
                <a:ext cx="554805" cy="3847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541" b="1" dirty="0"/>
                  <a:t>c</a:t>
                </a:r>
              </a:p>
            </p:txBody>
          </p:sp>
        </p:grp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E5922875-408C-3176-34A1-2691136066DA}"/>
                </a:ext>
              </a:extLst>
            </p:cNvPr>
            <p:cNvSpPr/>
            <p:nvPr/>
          </p:nvSpPr>
          <p:spPr>
            <a:xfrm>
              <a:off x="3604516" y="4735859"/>
              <a:ext cx="570796" cy="10853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47680461-9144-1887-9208-05C3411ED940}"/>
                </a:ext>
              </a:extLst>
            </p:cNvPr>
            <p:cNvSpPr/>
            <p:nvPr/>
          </p:nvSpPr>
          <p:spPr>
            <a:xfrm>
              <a:off x="5524068" y="4723874"/>
              <a:ext cx="1823268" cy="2263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4D846968-47B4-F54D-E436-A5CBC4A95932}"/>
                </a:ext>
              </a:extLst>
            </p:cNvPr>
            <p:cNvSpPr/>
            <p:nvPr/>
          </p:nvSpPr>
          <p:spPr>
            <a:xfrm>
              <a:off x="8826094" y="4730817"/>
              <a:ext cx="1823268" cy="2263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41"/>
            </a:p>
          </p:txBody>
        </p: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DB87AACD-9AC7-4536-50BF-1C4D4F5B8FAD}"/>
              </a:ext>
            </a:extLst>
          </p:cNvPr>
          <p:cNvSpPr txBox="1"/>
          <p:nvPr/>
        </p:nvSpPr>
        <p:spPr>
          <a:xfrm>
            <a:off x="164798" y="1069564"/>
            <a:ext cx="3301317" cy="3294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541" b="1" dirty="0"/>
              <a:t>Supplementary Figure 1</a:t>
            </a:r>
          </a:p>
        </p:txBody>
      </p: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E1D0326E-CB01-B9CB-9600-9E5BDAC0EDF3}"/>
              </a:ext>
            </a:extLst>
          </p:cNvPr>
          <p:cNvCxnSpPr>
            <a:cxnSpLocks/>
          </p:cNvCxnSpPr>
          <p:nvPr/>
        </p:nvCxnSpPr>
        <p:spPr>
          <a:xfrm>
            <a:off x="5691818" y="1652753"/>
            <a:ext cx="0" cy="30825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3DA14207-617F-F267-853D-B4C29B0AA902}"/>
              </a:ext>
            </a:extLst>
          </p:cNvPr>
          <p:cNvCxnSpPr>
            <a:cxnSpLocks/>
          </p:cNvCxnSpPr>
          <p:nvPr/>
        </p:nvCxnSpPr>
        <p:spPr>
          <a:xfrm>
            <a:off x="4889801" y="3463303"/>
            <a:ext cx="0" cy="308250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E307BCF6-5DEA-0276-0477-6BBF5B70B173}"/>
              </a:ext>
            </a:extLst>
          </p:cNvPr>
          <p:cNvCxnSpPr>
            <a:cxnSpLocks/>
          </p:cNvCxnSpPr>
          <p:nvPr/>
        </p:nvCxnSpPr>
        <p:spPr>
          <a:xfrm>
            <a:off x="5339926" y="5020540"/>
            <a:ext cx="0" cy="308250"/>
          </a:xfrm>
          <a:prstGeom prst="straightConnector1">
            <a:avLst/>
          </a:prstGeom>
          <a:ln w="952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B449EBF5-6EBD-E1B3-D298-BA495893CF92}"/>
              </a:ext>
            </a:extLst>
          </p:cNvPr>
          <p:cNvSpPr/>
          <p:nvPr/>
        </p:nvSpPr>
        <p:spPr>
          <a:xfrm>
            <a:off x="4401425" y="5185910"/>
            <a:ext cx="1889732" cy="198581"/>
          </a:xfrm>
          <a:prstGeom prst="round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41"/>
          </a:p>
        </p:txBody>
      </p:sp>
      <p:sp>
        <p:nvSpPr>
          <p:cNvPr id="86" name="Rectangle: Rounded Corners 85">
            <a:extLst>
              <a:ext uri="{FF2B5EF4-FFF2-40B4-BE49-F238E27FC236}">
                <a16:creationId xmlns:a16="http://schemas.microsoft.com/office/drawing/2014/main" id="{404DE2AA-5028-7A15-30A1-0F389567D73C}"/>
              </a:ext>
            </a:extLst>
          </p:cNvPr>
          <p:cNvSpPr/>
          <p:nvPr/>
        </p:nvSpPr>
        <p:spPr>
          <a:xfrm>
            <a:off x="4368345" y="5263621"/>
            <a:ext cx="1946444" cy="186159"/>
          </a:xfrm>
          <a:prstGeom prst="roundRect">
            <a:avLst/>
          </a:prstGeom>
          <a:solidFill>
            <a:schemeClr val="bg1"/>
          </a:solidFill>
          <a:ln w="9525"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41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B808881-F073-3709-10EE-2BD50A4B33E0}"/>
              </a:ext>
            </a:extLst>
          </p:cNvPr>
          <p:cNvSpPr txBox="1"/>
          <p:nvPr/>
        </p:nvSpPr>
        <p:spPr>
          <a:xfrm>
            <a:off x="1233155" y="5957171"/>
            <a:ext cx="5221031" cy="3294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541" dirty="0"/>
              <a:t>NM_000709.4:c.109-15T&gt;A </a:t>
            </a:r>
            <a:endParaRPr lang="en-GB" sz="154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ABFE4E4-38C1-91D3-DFC4-81E4A1522182}"/>
              </a:ext>
            </a:extLst>
          </p:cNvPr>
          <p:cNvSpPr txBox="1"/>
          <p:nvPr/>
        </p:nvSpPr>
        <p:spPr>
          <a:xfrm rot="19370105">
            <a:off x="4402623" y="3012661"/>
            <a:ext cx="1524205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99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.109-15T&gt;A</a:t>
            </a:r>
            <a:endParaRPr lang="en-GB" sz="1199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4FD4967-CE26-1604-4F02-84D1404E97C6}"/>
              </a:ext>
            </a:extLst>
          </p:cNvPr>
          <p:cNvSpPr txBox="1"/>
          <p:nvPr/>
        </p:nvSpPr>
        <p:spPr>
          <a:xfrm>
            <a:off x="615202" y="3779507"/>
            <a:ext cx="5221031" cy="2768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199" b="1" i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BCKDHA</a:t>
            </a:r>
            <a:endParaRPr lang="en-GB" sz="1199" b="1" i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743756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DF144-2799-8AF2-C523-265D24EFD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3200" b="1" dirty="0"/>
              <a:t>Supplementary Figure 1 Legend</a:t>
            </a:r>
            <a:endParaRPr lang="en-GB" sz="32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2926D7-DB49-85E2-ED7B-F35EF4F63F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 algn="just">
              <a:buNone/>
            </a:pPr>
            <a:r>
              <a:rPr lang="en-GB" sz="1884" dirty="0"/>
              <a:t>Genomic and transcript-level characterization of the intronic variant NM_000709.4:c.109-15T&gt;A in the </a:t>
            </a:r>
            <a:r>
              <a:rPr lang="en-GB" sz="1884" i="1" dirty="0"/>
              <a:t>BCKDHA</a:t>
            </a:r>
            <a:r>
              <a:rPr lang="en-GB" sz="1884" dirty="0"/>
              <a:t> gene.</a:t>
            </a:r>
          </a:p>
          <a:p>
            <a:pPr marL="0" indent="0" algn="just">
              <a:buNone/>
            </a:pPr>
            <a:r>
              <a:rPr lang="en-GB" sz="1884" dirty="0"/>
              <a:t>(a) The shaded region highlights a local depletion of intronic variation in Genome Aggregation (</a:t>
            </a:r>
            <a:r>
              <a:rPr lang="en-GB" sz="1884" dirty="0" err="1"/>
              <a:t>gnomAD</a:t>
            </a:r>
            <a:r>
              <a:rPr lang="en-GB" sz="1884" dirty="0"/>
              <a:t>) Database, v4.1.0, suggesting evolutionary constraint of potential functional relevance. The position of the c.109-15T&gt;A variant is indicated by an arrow within this conserved segment.</a:t>
            </a:r>
          </a:p>
          <a:p>
            <a:pPr marL="0" indent="0" algn="just">
              <a:buNone/>
            </a:pPr>
            <a:r>
              <a:rPr lang="en-GB" sz="1884" dirty="0"/>
              <a:t>(b) Schematic representation of the </a:t>
            </a:r>
            <a:r>
              <a:rPr lang="en-GB" sz="1884" i="1" dirty="0"/>
              <a:t>BCKDHA</a:t>
            </a:r>
            <a:r>
              <a:rPr lang="en-GB" sz="1884" dirty="0"/>
              <a:t> gene structure, showing exon–intron boundaries. Exons are depicted as boxes, with the variant mapped relative to the gene structure (arrow).</a:t>
            </a:r>
          </a:p>
          <a:p>
            <a:pPr marL="0" indent="0" algn="just">
              <a:buNone/>
            </a:pPr>
            <a:r>
              <a:rPr lang="en-GB" sz="1884" dirty="0"/>
              <a:t>(c) Sanger sequencing of reverse-transcribed RNA from the patient sample with homozygous c.109-15T&gt;A reveals the insertion of an additional 14 nucleotides, highlighted in yellow, in the mRNA transcript between exon 1 and exon 2.</a:t>
            </a:r>
          </a:p>
        </p:txBody>
      </p:sp>
    </p:spTree>
    <p:extLst>
      <p:ext uri="{BB962C8B-B14F-4D97-AF65-F5344CB8AC3E}">
        <p14:creationId xmlns:p14="http://schemas.microsoft.com/office/powerpoint/2010/main" val="3869548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12a5d77-fb98-4eee-af32-1334d8f04a53}" enabled="0" method="" siteId="{912a5d77-fb98-4eee-af32-1334d8f04a5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0</TotalTime>
  <Words>236</Words>
  <Application>Microsoft Office PowerPoint</Application>
  <PresentationFormat>Custom</PresentationFormat>
  <Paragraphs>1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Supplementary Figure 1 Legen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zzal, Reham</dc:creator>
  <cp:lastModifiedBy>Nazzal, Reham</cp:lastModifiedBy>
  <cp:revision>3</cp:revision>
  <dcterms:created xsi:type="dcterms:W3CDTF">2025-05-07T14:07:30Z</dcterms:created>
  <dcterms:modified xsi:type="dcterms:W3CDTF">2026-01-24T23:43:48Z</dcterms:modified>
</cp:coreProperties>
</file>